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9" r:id="rId3"/>
  </p:sldIdLst>
  <p:sldSz cx="6858000" cy="9144000" type="screen4x3"/>
  <p:notesSz cx="6797675" cy="987425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016" autoAdjust="0"/>
    <p:restoredTop sz="94660"/>
  </p:normalViewPr>
  <p:slideViewPr>
    <p:cSldViewPr>
      <p:cViewPr varScale="1">
        <p:scale>
          <a:sx n="83" d="100"/>
          <a:sy n="83" d="100"/>
        </p:scale>
        <p:origin x="2958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6FF5E5-D371-4D2C-8C2E-19A9F27CD7F4}" type="datetimeFigureOut">
              <a:rPr lang="es-ES" smtClean="0"/>
              <a:t>20/08/2020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5075"/>
            <a:ext cx="2498725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51388"/>
            <a:ext cx="5438775" cy="38893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95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37895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2AB4A9-2B9A-4469-9DD8-942D912C63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23612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aseline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ly </a:t>
            </a:r>
            <a:r>
              <a:rPr lang="en-US" sz="1200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ublets</a:t>
            </a:r>
            <a:endParaRPr lang="es-E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2AB4A9-2B9A-4469-9DD8-942D912C6378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79517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3533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5257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4469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3104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55791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4400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5102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96107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8695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0655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54312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DCAA0-ED4C-456F-B127-F5780B5E18B3}" type="datetimeFigureOut">
              <a:rPr lang="es-ES" smtClean="0"/>
              <a:pPr/>
              <a:t>20/08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6559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CuadroTexto 1"/>
          <p:cNvSpPr txBox="1"/>
          <p:nvPr/>
        </p:nvSpPr>
        <p:spPr>
          <a:xfrm>
            <a:off x="0" y="0"/>
            <a:ext cx="1196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Imagen 21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4" y="539552"/>
            <a:ext cx="6238240" cy="3553460"/>
          </a:xfrm>
          <a:prstGeom prst="rect">
            <a:avLst/>
          </a:prstGeom>
        </p:spPr>
      </p:pic>
      <p:sp>
        <p:nvSpPr>
          <p:cNvPr id="5" name="Rectángulo 4"/>
          <p:cNvSpPr/>
          <p:nvPr/>
        </p:nvSpPr>
        <p:spPr>
          <a:xfrm>
            <a:off x="464674" y="4572000"/>
            <a:ext cx="577657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moter analysis of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dm1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s. Schematic representation of regulatory elements found in promoters from human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DM1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NF683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s as well as the different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dm1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 identified in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corhynchus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ykiss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 analysis was performed using a region of 1,000bp upstream of the starting methionine using the match tool in the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fac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oftware comparing the elements found to high confidence regulatory elements from eukaryotes contained in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facBD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19.2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s-E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87461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uadroTexto 1"/>
          <p:cNvSpPr txBox="1"/>
          <p:nvPr/>
        </p:nvSpPr>
        <p:spPr>
          <a:xfrm>
            <a:off x="0" y="0"/>
            <a:ext cx="1196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Imagen 20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376" y="755576"/>
            <a:ext cx="5400040" cy="3997960"/>
          </a:xfrm>
          <a:prstGeom prst="rect">
            <a:avLst/>
          </a:prstGeom>
        </p:spPr>
      </p:pic>
      <p:sp>
        <p:nvSpPr>
          <p:cNvPr id="2" name="Rectángulo 1"/>
          <p:cNvSpPr/>
          <p:nvPr/>
        </p:nvSpPr>
        <p:spPr>
          <a:xfrm>
            <a:off x="476672" y="5212075"/>
            <a:ext cx="568863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analysis of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.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ykiss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rdm1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s in isolated B cells and T cells from spleen. The transcript levels of all rainbow trout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dm1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 was analyzed in splenic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D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 cells and CD8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 cells. Gene expression data were normalized against the endogenous control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f-1α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are shown as relative expression levels (means + SD; n = 4). No significant differences were identified comparing levels of expression in the two cell types.</a:t>
            </a:r>
            <a:endParaRPr lang="es-E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193500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05</TotalTime>
  <Words>169</Words>
  <Application>Microsoft Office PowerPoint</Application>
  <PresentationFormat>Presentación en pantalla (4:3)</PresentationFormat>
  <Paragraphs>6</Paragraphs>
  <Slides>2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olina Tafalla</dc:creator>
  <cp:lastModifiedBy>Carolina Tafalla</cp:lastModifiedBy>
  <cp:revision>399</cp:revision>
  <cp:lastPrinted>2019-06-14T08:47:33Z</cp:lastPrinted>
  <dcterms:created xsi:type="dcterms:W3CDTF">2018-05-10T11:02:11Z</dcterms:created>
  <dcterms:modified xsi:type="dcterms:W3CDTF">2020-08-20T14:18:59Z</dcterms:modified>
</cp:coreProperties>
</file>